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82" autoAdjust="0"/>
    <p:restoredTop sz="94660"/>
  </p:normalViewPr>
  <p:slideViewPr>
    <p:cSldViewPr snapToGrid="0">
      <p:cViewPr>
        <p:scale>
          <a:sx n="91" d="100"/>
          <a:sy n="91" d="100"/>
        </p:scale>
        <p:origin x="1068" y="5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09B724-40A8-326A-AA78-A83C1EDE69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CC73E9-2554-7A7B-1D58-AB110DF1A2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6C74AE-DF17-F00C-8957-BA56AACD9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3F8BFA-54C4-8120-63EA-358A19B06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7622A2-F603-2989-3185-27F853BB7B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850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64C78A-7066-87F9-5FAC-1C4DCE7CCB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AE18EA-E3E7-E47F-5CF3-F129612DE1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7BD107-87E1-54BE-CA5B-B388D91FEF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AAD795-45D9-7146-9F91-12A2589D1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C21715-74C5-2F3A-4F62-B8CF40047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275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A5E2593-36ED-B0BD-2DA4-2407A2908B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927FCB-7648-A714-D193-70C412033A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E362A8-7218-07D3-DA1D-27BFB80B7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58F148-31E4-A888-A031-A35E43B34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3B6452-1B61-EC74-CFDF-E6FBAECDA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871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AD9397-60C5-BD39-9BAA-4604364924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DCFD86-BF40-7F2B-4702-36147995BB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6E53F2-88A7-69B1-6239-7ED39D221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C358A1-4369-2F87-1D1C-2D5F990F9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AAFEFA-CA9E-0C9D-654F-C34765A01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323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899F34-391C-35E5-A8ED-09E1F9FA4F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777C57-D74A-F5C8-2699-B3657719F3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80219F-96B8-0584-6DEB-5CDAEDC2F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687854-9B97-25C3-3097-6CDDFA17B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EDF752-BA90-D3B5-3EE0-A41B52A52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702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4BEE8-C684-3D05-4399-E45111F01D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A7337F-7C8F-69DB-9DD7-5F17EF3EB5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19BC82-D333-4363-42F0-644709150C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095660-A437-48C1-F520-932631C08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A41AD1-D128-35B4-4FA1-E53610C92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112A06-38A3-4B02-81E5-7612B3BEE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482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054D24-708C-449E-6B59-A3B689DEED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896206-FECB-1AD8-03BB-5EF796322D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5BDDE6-41CA-6A57-8070-864D62C66B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2715B5-7893-FABB-98E2-540CEF8A13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4EAD733-B4BE-A374-7312-9DB3A8C5F8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76075D-9482-5FD5-3C79-7ADA14BBD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50903D-95CB-23EC-F2D3-53205AC1C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4F7D1A-58C8-DD79-1C69-FE9A5D278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746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050BB-CE64-B0F3-894D-82075E3DFB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D1F4AF3-FA45-0A5A-7B05-AF8BC61E2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F7FB67-43DF-7CBC-C983-F656BA51E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E29E477-2A1A-6392-FBAF-8CF8BABBF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94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3BD7CFC-6E11-67E2-DE83-E9CBC7B55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0B5FFD-FA3A-5667-E4A3-EDC94A22E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5809B47-7431-252B-BF2F-22AAB5338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138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E6DAA-7FCB-4FDE-26FC-A1FC31A185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31CABE-49FE-2A01-C2BC-AA85A0CDB2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1C7332-F2F2-AEB9-2658-B48BD55D5B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EAB822-D025-063C-4559-5A64A6850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AE1933-DFEA-676A-3CA6-8267A56D4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014D97-9CFF-21C3-EE0E-AF2E6E7D8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354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5459F0-9CBE-B771-9FF7-5E2ABE3B5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61A360-3AFF-3C8C-C627-CD5FF84E87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EE1F79-7BD8-A12C-A7C3-2F5F5D1ECB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F4E37B-2BBD-FF8B-DB32-BA951E646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47B1F8-532C-736C-5626-64CD5915C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61F2F3-95B6-F212-6E8A-D7FE1413B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898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43FEC7-8FC4-0DFF-6125-A2B7FD329F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91A6F9-100E-80D8-2C2E-EFB6D75BCE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12772A-5F88-C281-1ECB-3279F40D6D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66E42D-CFFF-464E-9584-643CE33E3EEA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CCE106-A700-2FA0-F46E-77BCD9EBDE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711841-1DE3-E80A-DC8C-6A6757FB48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8CD3E3-CF0C-4650-988A-0DDD4DE72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556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microsoft.com/office/2007/relationships/hdphoto" Target="../media/hdphoto3.wdp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>
            <a:extLst>
              <a:ext uri="{FF2B5EF4-FFF2-40B4-BE49-F238E27FC236}">
                <a16:creationId xmlns:a16="http://schemas.microsoft.com/office/drawing/2014/main" id="{733A8BFA-3FCD-921F-3ADB-BFC2E259C81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35" t="20164" r="14286" b="19197"/>
          <a:stretch>
            <a:fillRect/>
          </a:stretch>
        </p:blipFill>
        <p:spPr bwMode="auto">
          <a:xfrm>
            <a:off x="2787299" y="403330"/>
            <a:ext cx="5536224" cy="5703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矩形">
            <a:extLst>
              <a:ext uri="{FF2B5EF4-FFF2-40B4-BE49-F238E27FC236}">
                <a16:creationId xmlns:a16="http://schemas.microsoft.com/office/drawing/2014/main" id="{AC9BEBBD-E475-5083-F135-A45A2004530A}"/>
              </a:ext>
            </a:extLst>
          </p:cNvPr>
          <p:cNvSpPr>
            <a:spLocks/>
          </p:cNvSpPr>
          <p:nvPr/>
        </p:nvSpPr>
        <p:spPr>
          <a:xfrm>
            <a:off x="0" y="0"/>
            <a:ext cx="966610" cy="315954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b="1" dirty="0">
                <a:latin typeface="Calibri" charset="0"/>
                <a:ea typeface="等线" charset="0"/>
                <a:cs typeface="Calibri" charset="0"/>
              </a:rPr>
              <a:t>Figure 1B</a:t>
            </a:r>
            <a:endParaRPr lang="zh-CN" altLang="en-US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C7DFF78-8205-8838-258A-3F614BEB2469}"/>
              </a:ext>
            </a:extLst>
          </p:cNvPr>
          <p:cNvSpPr/>
          <p:nvPr/>
        </p:nvSpPr>
        <p:spPr>
          <a:xfrm>
            <a:off x="3640347" y="977463"/>
            <a:ext cx="4063736" cy="84583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矩形">
            <a:extLst>
              <a:ext uri="{FF2B5EF4-FFF2-40B4-BE49-F238E27FC236}">
                <a16:creationId xmlns:a16="http://schemas.microsoft.com/office/drawing/2014/main" id="{0FF4CB1F-D02C-C4E4-816C-D8C7EC08E86B}"/>
              </a:ext>
            </a:extLst>
          </p:cNvPr>
          <p:cNvSpPr>
            <a:spLocks/>
          </p:cNvSpPr>
          <p:nvPr/>
        </p:nvSpPr>
        <p:spPr>
          <a:xfrm>
            <a:off x="1438596" y="1473693"/>
            <a:ext cx="1348703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1B/BRUCE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3630A5B-15FC-001B-D4F3-3B1F3B96304D}"/>
              </a:ext>
            </a:extLst>
          </p:cNvPr>
          <p:cNvSpPr/>
          <p:nvPr/>
        </p:nvSpPr>
        <p:spPr>
          <a:xfrm>
            <a:off x="3062664" y="2535725"/>
            <a:ext cx="4977749" cy="1016772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矩形">
            <a:extLst>
              <a:ext uri="{FF2B5EF4-FFF2-40B4-BE49-F238E27FC236}">
                <a16:creationId xmlns:a16="http://schemas.microsoft.com/office/drawing/2014/main" id="{0F51E67B-E3AD-A6B9-F808-A696D242E57E}"/>
              </a:ext>
            </a:extLst>
          </p:cNvPr>
          <p:cNvSpPr>
            <a:spLocks/>
          </p:cNvSpPr>
          <p:nvPr/>
        </p:nvSpPr>
        <p:spPr>
          <a:xfrm>
            <a:off x="1549717" y="2887732"/>
            <a:ext cx="1237582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1B/PTEN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44FA7C8-8279-8CCB-8389-68BEC3190EB5}"/>
              </a:ext>
            </a:extLst>
          </p:cNvPr>
          <p:cNvSpPr/>
          <p:nvPr/>
        </p:nvSpPr>
        <p:spPr>
          <a:xfrm>
            <a:off x="3567965" y="3843068"/>
            <a:ext cx="4136118" cy="918118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矩形">
            <a:extLst>
              <a:ext uri="{FF2B5EF4-FFF2-40B4-BE49-F238E27FC236}">
                <a16:creationId xmlns:a16="http://schemas.microsoft.com/office/drawing/2014/main" id="{7E97C6CB-2DB9-01CB-2F42-7CFD77D29DE2}"/>
              </a:ext>
            </a:extLst>
          </p:cNvPr>
          <p:cNvSpPr>
            <a:spLocks/>
          </p:cNvSpPr>
          <p:nvPr/>
        </p:nvSpPr>
        <p:spPr>
          <a:xfrm>
            <a:off x="1503716" y="4301771"/>
            <a:ext cx="1227003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1B/Actin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58810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06CD1D5-E704-A618-9014-D2EF451C47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61B2DEC0-D6F7-F120-178B-43CD5191AC5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161" t="58072" r="22113" b="8199"/>
          <a:stretch>
            <a:fillRect/>
          </a:stretch>
        </p:blipFill>
        <p:spPr bwMode="auto">
          <a:xfrm>
            <a:off x="7812014" y="2104638"/>
            <a:ext cx="4240917" cy="31900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C878E22-6ED0-B276-3E90-914BACFCDFA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161" t="1048" r="22113" b="41961"/>
          <a:stretch>
            <a:fillRect/>
          </a:stretch>
        </p:blipFill>
        <p:spPr bwMode="auto">
          <a:xfrm>
            <a:off x="1829422" y="711303"/>
            <a:ext cx="4476795" cy="56897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矩形">
            <a:extLst>
              <a:ext uri="{FF2B5EF4-FFF2-40B4-BE49-F238E27FC236}">
                <a16:creationId xmlns:a16="http://schemas.microsoft.com/office/drawing/2014/main" id="{6D33BBC1-7DC6-FCB7-F087-AE40E6F3CEFA}"/>
              </a:ext>
            </a:extLst>
          </p:cNvPr>
          <p:cNvSpPr>
            <a:spLocks/>
          </p:cNvSpPr>
          <p:nvPr/>
        </p:nvSpPr>
        <p:spPr>
          <a:xfrm>
            <a:off x="0" y="0"/>
            <a:ext cx="976228" cy="315954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b="1" dirty="0">
                <a:latin typeface="Calibri" charset="0"/>
                <a:ea typeface="等线" charset="0"/>
                <a:cs typeface="Calibri" charset="0"/>
              </a:rPr>
              <a:t>Figure 2A</a:t>
            </a:r>
            <a:endParaRPr lang="zh-CN" altLang="en-US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10" name="矩形">
            <a:extLst>
              <a:ext uri="{FF2B5EF4-FFF2-40B4-BE49-F238E27FC236}">
                <a16:creationId xmlns:a16="http://schemas.microsoft.com/office/drawing/2014/main" id="{0869E91F-42C6-2FBE-FA64-9DACD56BEDD1}"/>
              </a:ext>
            </a:extLst>
          </p:cNvPr>
          <p:cNvSpPr>
            <a:spLocks/>
          </p:cNvSpPr>
          <p:nvPr/>
        </p:nvSpPr>
        <p:spPr>
          <a:xfrm>
            <a:off x="421024" y="5841158"/>
            <a:ext cx="1408398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2A/Tubulin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4B84F47-1035-63D3-0DF6-5D75C9E72C0D}"/>
              </a:ext>
            </a:extLst>
          </p:cNvPr>
          <p:cNvSpPr/>
          <p:nvPr/>
        </p:nvSpPr>
        <p:spPr>
          <a:xfrm>
            <a:off x="2343817" y="3201854"/>
            <a:ext cx="3009113" cy="29794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矩形">
            <a:extLst>
              <a:ext uri="{FF2B5EF4-FFF2-40B4-BE49-F238E27FC236}">
                <a16:creationId xmlns:a16="http://schemas.microsoft.com/office/drawing/2014/main" id="{346A1E05-C9AE-5495-2649-4D3666DF0F59}"/>
              </a:ext>
            </a:extLst>
          </p:cNvPr>
          <p:cNvSpPr>
            <a:spLocks/>
          </p:cNvSpPr>
          <p:nvPr/>
        </p:nvSpPr>
        <p:spPr>
          <a:xfrm>
            <a:off x="160119" y="3174204"/>
            <a:ext cx="1669303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2A/pGSK3</a:t>
            </a:r>
            <a:r>
              <a:rPr lang="en-US" altLang="zh-CN" sz="1400" b="1" dirty="0">
                <a:latin typeface="Symbol" panose="05050102010706020507" pitchFamily="18" charset="2"/>
                <a:ea typeface="等线" charset="0"/>
                <a:cs typeface="Calibri" charset="0"/>
              </a:rPr>
              <a:t>b</a:t>
            </a:r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-S9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96AD8A2-F41E-A39E-2E97-8F426D6327F4}"/>
              </a:ext>
            </a:extLst>
          </p:cNvPr>
          <p:cNvSpPr/>
          <p:nvPr/>
        </p:nvSpPr>
        <p:spPr>
          <a:xfrm>
            <a:off x="8281811" y="3153104"/>
            <a:ext cx="3584369" cy="58067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矩形">
            <a:extLst>
              <a:ext uri="{FF2B5EF4-FFF2-40B4-BE49-F238E27FC236}">
                <a16:creationId xmlns:a16="http://schemas.microsoft.com/office/drawing/2014/main" id="{98DCBA39-0A4B-7708-6B02-9437C6073C87}"/>
              </a:ext>
            </a:extLst>
          </p:cNvPr>
          <p:cNvSpPr>
            <a:spLocks/>
          </p:cNvSpPr>
          <p:nvPr/>
        </p:nvSpPr>
        <p:spPr>
          <a:xfrm>
            <a:off x="6469723" y="3301801"/>
            <a:ext cx="1342291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2A/GSK3</a:t>
            </a:r>
            <a:r>
              <a:rPr lang="en-US" altLang="zh-CN" sz="1400" b="1" dirty="0">
                <a:latin typeface="Symbol" panose="05050102010706020507" pitchFamily="18" charset="2"/>
                <a:ea typeface="等线" charset="0"/>
                <a:cs typeface="Calibri" charset="0"/>
              </a:rPr>
              <a:t>b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15" name="矩形">
            <a:extLst>
              <a:ext uri="{FF2B5EF4-FFF2-40B4-BE49-F238E27FC236}">
                <a16:creationId xmlns:a16="http://schemas.microsoft.com/office/drawing/2014/main" id="{F6FCB93A-F8CA-3048-A6D5-44ACF506ECD3}"/>
              </a:ext>
            </a:extLst>
          </p:cNvPr>
          <p:cNvSpPr>
            <a:spLocks/>
          </p:cNvSpPr>
          <p:nvPr/>
        </p:nvSpPr>
        <p:spPr>
          <a:xfrm>
            <a:off x="6669971" y="4410665"/>
            <a:ext cx="1142043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2A/AKT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280597E-B1FB-9C60-B2A1-CFAE63EF3AB6}"/>
              </a:ext>
            </a:extLst>
          </p:cNvPr>
          <p:cNvSpPr/>
          <p:nvPr/>
        </p:nvSpPr>
        <p:spPr>
          <a:xfrm>
            <a:off x="8839201" y="4210141"/>
            <a:ext cx="2490951" cy="6554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20" name="矩形">
            <a:extLst>
              <a:ext uri="{FF2B5EF4-FFF2-40B4-BE49-F238E27FC236}">
                <a16:creationId xmlns:a16="http://schemas.microsoft.com/office/drawing/2014/main" id="{634F2807-10DC-E395-C26E-FA31446DB230}"/>
              </a:ext>
            </a:extLst>
          </p:cNvPr>
          <p:cNvSpPr>
            <a:spLocks/>
          </p:cNvSpPr>
          <p:nvPr/>
        </p:nvSpPr>
        <p:spPr>
          <a:xfrm>
            <a:off x="169737" y="2754091"/>
            <a:ext cx="1659685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2A/pAKT-S473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6E913D8-8B88-B03F-F7C1-9B87DD5AE3C0}"/>
              </a:ext>
            </a:extLst>
          </p:cNvPr>
          <p:cNvSpPr/>
          <p:nvPr/>
        </p:nvSpPr>
        <p:spPr>
          <a:xfrm>
            <a:off x="2343816" y="2644808"/>
            <a:ext cx="3009113" cy="472964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42CB286-5503-A5E4-BACA-BC657391BEA2}"/>
              </a:ext>
            </a:extLst>
          </p:cNvPr>
          <p:cNvSpPr/>
          <p:nvPr/>
        </p:nvSpPr>
        <p:spPr>
          <a:xfrm>
            <a:off x="2798915" y="5755869"/>
            <a:ext cx="2897702" cy="42497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4711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CF623FE-02DE-B889-2188-418FF3C2AD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0CEBED-AF9C-D72E-3361-2B0E0EF360B5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107050" cy="266620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 defTabSz="514350" eaLnBrk="1" fontAlgn="auto" latinLnBrk="0" hangingPunct="1">
              <a:lnSpc>
                <a:spcPct val="90000"/>
              </a:lnSpc>
              <a:spcBef>
                <a:spcPts val="0"/>
              </a:spcBef>
              <a:buNone/>
              <a:defRPr sz="2475" kern="1200">
                <a:solidFill>
                  <a:schemeClr val="tx1"/>
                </a:solidFill>
                <a:latin typeface="Calibri Light" charset="0"/>
                <a:ea typeface="等线 Light" charset="0"/>
                <a:cs typeface="Calibri Light" charset="0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cs typeface="Calibri" panose="020F0502020204030204" pitchFamily="34" charset="0"/>
              </a:rPr>
              <a:t>Figure 6A</a:t>
            </a:r>
          </a:p>
        </p:txBody>
      </p:sp>
      <p:pic>
        <p:nvPicPr>
          <p:cNvPr id="4" name="Picture 3" descr="A white board with black ink marks&#10;&#10;AI-generated content may be incorrect.">
            <a:extLst>
              <a:ext uri="{FF2B5EF4-FFF2-40B4-BE49-F238E27FC236}">
                <a16:creationId xmlns:a16="http://schemas.microsoft.com/office/drawing/2014/main" id="{7D21C192-E88D-AB85-5288-47A60FA3B8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650335" y="1084263"/>
            <a:ext cx="6541142" cy="4905856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AE68DCAB-A263-95CD-D7EC-482C4A0BF4F8}"/>
              </a:ext>
            </a:extLst>
          </p:cNvPr>
          <p:cNvSpPr/>
          <p:nvPr/>
        </p:nvSpPr>
        <p:spPr>
          <a:xfrm>
            <a:off x="4180936" y="899849"/>
            <a:ext cx="3022121" cy="733245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矩形">
            <a:extLst>
              <a:ext uri="{FF2B5EF4-FFF2-40B4-BE49-F238E27FC236}">
                <a16:creationId xmlns:a16="http://schemas.microsoft.com/office/drawing/2014/main" id="{54C4C0EC-05E4-D6F1-66AB-EAEF1B49EF6B}"/>
              </a:ext>
            </a:extLst>
          </p:cNvPr>
          <p:cNvSpPr>
            <a:spLocks/>
          </p:cNvSpPr>
          <p:nvPr/>
        </p:nvSpPr>
        <p:spPr>
          <a:xfrm>
            <a:off x="1917129" y="1219107"/>
            <a:ext cx="1382943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6A/pSTAT3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D65652C-AE8C-60D5-B4F3-40D2D2DB399A}"/>
              </a:ext>
            </a:extLst>
          </p:cNvPr>
          <p:cNvSpPr/>
          <p:nvPr/>
        </p:nvSpPr>
        <p:spPr>
          <a:xfrm>
            <a:off x="4339518" y="5035126"/>
            <a:ext cx="3022121" cy="27012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矩形">
            <a:extLst>
              <a:ext uri="{FF2B5EF4-FFF2-40B4-BE49-F238E27FC236}">
                <a16:creationId xmlns:a16="http://schemas.microsoft.com/office/drawing/2014/main" id="{471674C0-7EB9-6699-D888-8C3BBF1597A8}"/>
              </a:ext>
            </a:extLst>
          </p:cNvPr>
          <p:cNvSpPr>
            <a:spLocks/>
          </p:cNvSpPr>
          <p:nvPr/>
        </p:nvSpPr>
        <p:spPr>
          <a:xfrm>
            <a:off x="2040560" y="5050848"/>
            <a:ext cx="1286763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6A/STAT3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FDC4618-6807-D14D-9378-90D9A8591F7B}"/>
              </a:ext>
            </a:extLst>
          </p:cNvPr>
          <p:cNvSpPr/>
          <p:nvPr/>
        </p:nvSpPr>
        <p:spPr>
          <a:xfrm>
            <a:off x="4339518" y="5632799"/>
            <a:ext cx="3022121" cy="1641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矩形">
            <a:extLst>
              <a:ext uri="{FF2B5EF4-FFF2-40B4-BE49-F238E27FC236}">
                <a16:creationId xmlns:a16="http://schemas.microsoft.com/office/drawing/2014/main" id="{AC0A6E3E-E432-4CE4-D76A-9F663FB01BA5}"/>
              </a:ext>
            </a:extLst>
          </p:cNvPr>
          <p:cNvSpPr>
            <a:spLocks/>
          </p:cNvSpPr>
          <p:nvPr/>
        </p:nvSpPr>
        <p:spPr>
          <a:xfrm>
            <a:off x="2040560" y="5598295"/>
            <a:ext cx="1235017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non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charset="0"/>
                <a:ea typeface="等线" charset="0"/>
                <a:cs typeface="Calibri" charset="0"/>
              </a:rPr>
              <a:t>Figure 6A/Actin</a:t>
            </a:r>
            <a:endParaRPr lang="zh-CN" altLang="en-US" sz="1400" b="1" dirty="0">
              <a:latin typeface="Calibri" charset="0"/>
              <a:ea typeface="等线" charset="0"/>
              <a:cs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55046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1CB239-49B7-A2CA-D813-FA04EA903F7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8751BD44-8F2A-71F0-D9BF-0D9A7BE46F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4503" y="4523383"/>
            <a:ext cx="1956986" cy="1579001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7976167-E4EC-DB78-2419-D5A7D2AF36F6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107050" cy="266620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 defTabSz="514350" eaLnBrk="1" fontAlgn="auto" latinLnBrk="0" hangingPunct="1">
              <a:lnSpc>
                <a:spcPct val="90000"/>
              </a:lnSpc>
              <a:spcBef>
                <a:spcPts val="0"/>
              </a:spcBef>
              <a:buNone/>
              <a:defRPr sz="2475" kern="1200">
                <a:solidFill>
                  <a:schemeClr val="tx1"/>
                </a:solidFill>
                <a:latin typeface="Calibri Light" charset="0"/>
                <a:ea typeface="等线 Light" charset="0"/>
                <a:cs typeface="Calibri Light" charset="0"/>
              </a:defRPr>
            </a:lvl1pPr>
          </a:lstStyle>
          <a:p>
            <a:r>
              <a:rPr lang="en-US" sz="1800" b="1" dirty="0">
                <a:latin typeface="Calibri" panose="020F0502020204030204" pitchFamily="34" charset="0"/>
                <a:cs typeface="Calibri" panose="020F0502020204030204" pitchFamily="34" charset="0"/>
              </a:rPr>
              <a:t>Figure 6C</a:t>
            </a:r>
          </a:p>
        </p:txBody>
      </p:sp>
      <p:pic>
        <p:nvPicPr>
          <p:cNvPr id="3" name="Picture 2" descr="A group of black and white objects&#10;&#10;AI-generated content may be incorrect.">
            <a:extLst>
              <a:ext uri="{FF2B5EF4-FFF2-40B4-BE49-F238E27FC236}">
                <a16:creationId xmlns:a16="http://schemas.microsoft.com/office/drawing/2014/main" id="{6ABCD5F5-C054-9DA7-69BA-C0B3F6BD0C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60" t="7397" r="49044" b="17030"/>
          <a:stretch/>
        </p:blipFill>
        <p:spPr>
          <a:xfrm>
            <a:off x="5580732" y="979181"/>
            <a:ext cx="1885069" cy="3256513"/>
          </a:xfrm>
          <a:prstGeom prst="rect">
            <a:avLst/>
          </a:prstGeom>
        </p:spPr>
      </p:pic>
      <p:pic>
        <p:nvPicPr>
          <p:cNvPr id="4" name="Picture 3" descr="A close-up of a test&#10;&#10;AI-generated content may be incorrect.">
            <a:extLst>
              <a:ext uri="{FF2B5EF4-FFF2-40B4-BE49-F238E27FC236}">
                <a16:creationId xmlns:a16="http://schemas.microsoft.com/office/drawing/2014/main" id="{F2018E6C-6090-38D7-494F-5FAEF1E9AE55}"/>
              </a:ext>
            </a:extLst>
          </p:cNvPr>
          <p:cNvPicPr>
            <a:picLocks noChangeAspect="1"/>
          </p:cNvPicPr>
          <p:nvPr/>
        </p:nvPicPr>
        <p:blipFill>
          <a:blip r:embed="rId4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227"/>
          <a:stretch/>
        </p:blipFill>
        <p:spPr>
          <a:xfrm>
            <a:off x="2286281" y="1055343"/>
            <a:ext cx="2074261" cy="325651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552682D-7BEB-2A19-CE9F-7BB682693309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5120" t="8260" r="49085" b="19706"/>
          <a:stretch/>
        </p:blipFill>
        <p:spPr>
          <a:xfrm>
            <a:off x="9082248" y="893660"/>
            <a:ext cx="2074261" cy="337514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F181F68-D051-1CA7-1C96-CBABC82665E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r="42136" b="7801"/>
          <a:stretch/>
        </p:blipFill>
        <p:spPr>
          <a:xfrm>
            <a:off x="9082247" y="4614649"/>
            <a:ext cx="2074262" cy="157948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C84D74F9-AE0E-ECED-5E59-BC448C26DF15}"/>
              </a:ext>
            </a:extLst>
          </p:cNvPr>
          <p:cNvSpPr txBox="1"/>
          <p:nvPr/>
        </p:nvSpPr>
        <p:spPr>
          <a:xfrm>
            <a:off x="1332445" y="5241350"/>
            <a:ext cx="11307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incul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2D83FE2-8E56-7C6B-3949-CAB18613E43F}"/>
              </a:ext>
            </a:extLst>
          </p:cNvPr>
          <p:cNvSpPr txBox="1"/>
          <p:nvPr/>
        </p:nvSpPr>
        <p:spPr>
          <a:xfrm>
            <a:off x="9754067" y="556052"/>
            <a:ext cx="1130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verlay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FB1FAE81-B6D2-7B72-2E17-AC2393D58337}"/>
              </a:ext>
            </a:extLst>
          </p:cNvPr>
          <p:cNvCxnSpPr>
            <a:cxnSpLocks/>
          </p:cNvCxnSpPr>
          <p:nvPr/>
        </p:nvCxnSpPr>
        <p:spPr>
          <a:xfrm>
            <a:off x="5423971" y="5152822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F87DC13-F911-2386-3D35-3FFFD16A8561}"/>
              </a:ext>
            </a:extLst>
          </p:cNvPr>
          <p:cNvCxnSpPr>
            <a:cxnSpLocks/>
          </p:cNvCxnSpPr>
          <p:nvPr/>
        </p:nvCxnSpPr>
        <p:spPr>
          <a:xfrm>
            <a:off x="5423971" y="5645200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CA9B5247-D15A-0C3F-43EA-D8A3A1291C10}"/>
              </a:ext>
            </a:extLst>
          </p:cNvPr>
          <p:cNvSpPr txBox="1"/>
          <p:nvPr/>
        </p:nvSpPr>
        <p:spPr>
          <a:xfrm>
            <a:off x="4763085" y="5469412"/>
            <a:ext cx="740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B0DE3F3-A7EA-1E42-962A-FC8029216975}"/>
              </a:ext>
            </a:extLst>
          </p:cNvPr>
          <p:cNvSpPr txBox="1"/>
          <p:nvPr/>
        </p:nvSpPr>
        <p:spPr>
          <a:xfrm>
            <a:off x="4756299" y="5034381"/>
            <a:ext cx="734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50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F0A401A-35A1-1815-F875-D73A1DDE6717}"/>
              </a:ext>
            </a:extLst>
          </p:cNvPr>
          <p:cNvCxnSpPr>
            <a:cxnSpLocks/>
          </p:cNvCxnSpPr>
          <p:nvPr/>
        </p:nvCxnSpPr>
        <p:spPr>
          <a:xfrm>
            <a:off x="5593367" y="3660273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77F18FCC-4862-2F5E-DA29-6F790F761B2F}"/>
              </a:ext>
            </a:extLst>
          </p:cNvPr>
          <p:cNvCxnSpPr>
            <a:cxnSpLocks/>
          </p:cNvCxnSpPr>
          <p:nvPr/>
        </p:nvCxnSpPr>
        <p:spPr>
          <a:xfrm>
            <a:off x="5593367" y="3789780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A00835BC-5762-A052-3EE8-C6E5D2AAE459}"/>
              </a:ext>
            </a:extLst>
          </p:cNvPr>
          <p:cNvSpPr txBox="1"/>
          <p:nvPr/>
        </p:nvSpPr>
        <p:spPr>
          <a:xfrm>
            <a:off x="4859054" y="3659664"/>
            <a:ext cx="636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5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98CD9EA-1978-5BA2-AB6F-AB2C4DD77643}"/>
              </a:ext>
            </a:extLst>
          </p:cNvPr>
          <p:cNvSpPr txBox="1"/>
          <p:nvPr/>
        </p:nvSpPr>
        <p:spPr>
          <a:xfrm>
            <a:off x="4859054" y="3486653"/>
            <a:ext cx="7343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1FEBB36D-9978-E6BA-3BA4-359896B9A79F}"/>
              </a:ext>
            </a:extLst>
          </p:cNvPr>
          <p:cNvCxnSpPr>
            <a:cxnSpLocks/>
          </p:cNvCxnSpPr>
          <p:nvPr/>
        </p:nvCxnSpPr>
        <p:spPr>
          <a:xfrm>
            <a:off x="5593367" y="3164500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C453B9C-663A-13C4-FF12-571F9131A0AB}"/>
              </a:ext>
            </a:extLst>
          </p:cNvPr>
          <p:cNvCxnSpPr>
            <a:cxnSpLocks/>
          </p:cNvCxnSpPr>
          <p:nvPr/>
        </p:nvCxnSpPr>
        <p:spPr>
          <a:xfrm>
            <a:off x="5593367" y="3037891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22A85B1C-2F60-92D6-F1D4-E9FCCAB68C90}"/>
              </a:ext>
            </a:extLst>
          </p:cNvPr>
          <p:cNvSpPr txBox="1"/>
          <p:nvPr/>
        </p:nvSpPr>
        <p:spPr>
          <a:xfrm>
            <a:off x="4859054" y="3040713"/>
            <a:ext cx="636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5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9B7F48D-B163-9EDB-5A97-51B3053B742E}"/>
              </a:ext>
            </a:extLst>
          </p:cNvPr>
          <p:cNvSpPr txBox="1"/>
          <p:nvPr/>
        </p:nvSpPr>
        <p:spPr>
          <a:xfrm>
            <a:off x="4859054" y="2832457"/>
            <a:ext cx="736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32D081B-AF08-A6A6-88F3-4155B9407023}"/>
              </a:ext>
            </a:extLst>
          </p:cNvPr>
          <p:cNvSpPr txBox="1"/>
          <p:nvPr/>
        </p:nvSpPr>
        <p:spPr>
          <a:xfrm>
            <a:off x="5734628" y="556052"/>
            <a:ext cx="16813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otein marker (</a:t>
            </a:r>
            <a:r>
              <a:rPr lang="en-US" sz="12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7D8511-AFF0-F706-D3C9-DFAD075C128D}"/>
              </a:ext>
            </a:extLst>
          </p:cNvPr>
          <p:cNvSpPr txBox="1"/>
          <p:nvPr/>
        </p:nvSpPr>
        <p:spPr>
          <a:xfrm>
            <a:off x="2007532" y="556052"/>
            <a:ext cx="27324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B results for STAT3, its phospho-form, </a:t>
            </a:r>
          </a:p>
          <a:p>
            <a:pPr algn="ctr"/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 Vinculin control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8F05AE4F-2A02-EFC6-1823-F87BD32BDFAD}"/>
              </a:ext>
            </a:extLst>
          </p:cNvPr>
          <p:cNvSpPr/>
          <p:nvPr/>
        </p:nvSpPr>
        <p:spPr>
          <a:xfrm>
            <a:off x="3151467" y="2848731"/>
            <a:ext cx="1130773" cy="254604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矩形">
            <a:extLst>
              <a:ext uri="{FF2B5EF4-FFF2-40B4-BE49-F238E27FC236}">
                <a16:creationId xmlns:a16="http://schemas.microsoft.com/office/drawing/2014/main" id="{619DDAC7-1ECF-C341-A50F-D46310B3C875}"/>
              </a:ext>
            </a:extLst>
          </p:cNvPr>
          <p:cNvSpPr>
            <a:spLocks/>
          </p:cNvSpPr>
          <p:nvPr/>
        </p:nvSpPr>
        <p:spPr>
          <a:xfrm>
            <a:off x="485051" y="3363041"/>
            <a:ext cx="2003485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squar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6C/pSTAT3-Y705</a:t>
            </a:r>
            <a:endParaRPr lang="zh-CN" altLang="en-US" sz="1400" b="1" dirty="0">
              <a:latin typeface="Calibri" panose="020F0502020204030204" pitchFamily="34" charset="0"/>
              <a:ea typeface="等线" charset="0"/>
              <a:cs typeface="Calibri" panose="020F0502020204030204" pitchFamily="34" charset="0"/>
            </a:endParaRPr>
          </a:p>
        </p:txBody>
      </p:sp>
      <p:sp>
        <p:nvSpPr>
          <p:cNvPr id="32" name="矩形">
            <a:extLst>
              <a:ext uri="{FF2B5EF4-FFF2-40B4-BE49-F238E27FC236}">
                <a16:creationId xmlns:a16="http://schemas.microsoft.com/office/drawing/2014/main" id="{B30F81DC-A3B0-01BB-58AC-EDA8581DFAC6}"/>
              </a:ext>
            </a:extLst>
          </p:cNvPr>
          <p:cNvSpPr>
            <a:spLocks/>
          </p:cNvSpPr>
          <p:nvPr/>
        </p:nvSpPr>
        <p:spPr>
          <a:xfrm>
            <a:off x="954499" y="2892729"/>
            <a:ext cx="1306748" cy="254398"/>
          </a:xfrm>
          <a:prstGeom prst="rect">
            <a:avLst/>
          </a:prstGeom>
          <a:noFill/>
          <a:ln w="9525" cap="flat" cmpd="sng">
            <a:noFill/>
            <a:prstDash val="solid"/>
            <a:miter/>
          </a:ln>
        </p:spPr>
        <p:txBody>
          <a:bodyPr vert="horz" wrap="square" lIns="38576" tIns="19289" rIns="38576" bIns="19289" anchor="t" anchorCtr="0">
            <a:prstTxWarp prst="textNoShape">
              <a:avLst/>
            </a:prstTxWarp>
            <a:spAutoFit/>
          </a:bodyPr>
          <a:lstStyle/>
          <a:p>
            <a:r>
              <a:rPr lang="en-US" altLang="zh-CN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6C/STAT3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C12ECDA-725E-47F0-7FF1-C691C8700A9C}"/>
              </a:ext>
            </a:extLst>
          </p:cNvPr>
          <p:cNvSpPr/>
          <p:nvPr/>
        </p:nvSpPr>
        <p:spPr>
          <a:xfrm>
            <a:off x="3151467" y="3371793"/>
            <a:ext cx="1130773" cy="254604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EDACED95-A977-F093-313C-C327DA416DF2}"/>
              </a:ext>
            </a:extLst>
          </p:cNvPr>
          <p:cNvSpPr/>
          <p:nvPr/>
        </p:nvSpPr>
        <p:spPr>
          <a:xfrm>
            <a:off x="2668804" y="5256105"/>
            <a:ext cx="1298868" cy="254604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586517F7-E5FD-C6C4-F217-B75266349509}"/>
              </a:ext>
            </a:extLst>
          </p:cNvPr>
          <p:cNvCxnSpPr>
            <a:cxnSpLocks/>
          </p:cNvCxnSpPr>
          <p:nvPr/>
        </p:nvCxnSpPr>
        <p:spPr>
          <a:xfrm>
            <a:off x="9098024" y="3191260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EAF65600-7DB5-6842-6B4A-CAAFB0B1EDB6}"/>
              </a:ext>
            </a:extLst>
          </p:cNvPr>
          <p:cNvCxnSpPr>
            <a:cxnSpLocks/>
          </p:cNvCxnSpPr>
          <p:nvPr/>
        </p:nvCxnSpPr>
        <p:spPr>
          <a:xfrm>
            <a:off x="9098024" y="3064651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95F82D42-836A-46DC-18A6-5710FA7F9345}"/>
              </a:ext>
            </a:extLst>
          </p:cNvPr>
          <p:cNvSpPr txBox="1"/>
          <p:nvPr/>
        </p:nvSpPr>
        <p:spPr>
          <a:xfrm>
            <a:off x="8363711" y="3067473"/>
            <a:ext cx="636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5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94CB61D-B332-F21A-9977-B47A7D5453E9}"/>
              </a:ext>
            </a:extLst>
          </p:cNvPr>
          <p:cNvSpPr txBox="1"/>
          <p:nvPr/>
        </p:nvSpPr>
        <p:spPr>
          <a:xfrm>
            <a:off x="8363711" y="2859217"/>
            <a:ext cx="736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B5B95FDA-53AC-CC59-6507-0001F7C9E224}"/>
              </a:ext>
            </a:extLst>
          </p:cNvPr>
          <p:cNvSpPr/>
          <p:nvPr/>
        </p:nvSpPr>
        <p:spPr>
          <a:xfrm>
            <a:off x="9652086" y="3054541"/>
            <a:ext cx="1373042" cy="254604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CBAA3A4E-BC4C-562F-3F55-CE670C8F091E}"/>
              </a:ext>
            </a:extLst>
          </p:cNvPr>
          <p:cNvSpPr/>
          <p:nvPr/>
        </p:nvSpPr>
        <p:spPr>
          <a:xfrm>
            <a:off x="9652086" y="3745764"/>
            <a:ext cx="1373042" cy="254604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ABFE128A-5F08-2FE3-D1C9-B4F88176DB91}"/>
              </a:ext>
            </a:extLst>
          </p:cNvPr>
          <p:cNvCxnSpPr>
            <a:cxnSpLocks/>
          </p:cNvCxnSpPr>
          <p:nvPr/>
        </p:nvCxnSpPr>
        <p:spPr>
          <a:xfrm>
            <a:off x="9175998" y="3733375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DB9CC004-FC92-C58C-4161-9D24815D18E1}"/>
              </a:ext>
            </a:extLst>
          </p:cNvPr>
          <p:cNvCxnSpPr>
            <a:cxnSpLocks/>
          </p:cNvCxnSpPr>
          <p:nvPr/>
        </p:nvCxnSpPr>
        <p:spPr>
          <a:xfrm>
            <a:off x="9175998" y="3862882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F9A99580-B5B7-E322-55AC-2DE62284997C}"/>
              </a:ext>
            </a:extLst>
          </p:cNvPr>
          <p:cNvSpPr txBox="1"/>
          <p:nvPr/>
        </p:nvSpPr>
        <p:spPr>
          <a:xfrm>
            <a:off x="8441685" y="3732766"/>
            <a:ext cx="636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5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25874B9-9F3D-33F5-FC2F-0129BC7FDE1B}"/>
              </a:ext>
            </a:extLst>
          </p:cNvPr>
          <p:cNvSpPr txBox="1"/>
          <p:nvPr/>
        </p:nvSpPr>
        <p:spPr>
          <a:xfrm>
            <a:off x="8441685" y="3559755"/>
            <a:ext cx="7343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0893C7D5-BFF3-B0E5-24CF-A2FC2D7D3F50}"/>
              </a:ext>
            </a:extLst>
          </p:cNvPr>
          <p:cNvCxnSpPr>
            <a:cxnSpLocks/>
          </p:cNvCxnSpPr>
          <p:nvPr/>
        </p:nvCxnSpPr>
        <p:spPr>
          <a:xfrm>
            <a:off x="8784877" y="5139209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B686F417-6425-4DEE-48B1-D8EC882863BF}"/>
              </a:ext>
            </a:extLst>
          </p:cNvPr>
          <p:cNvCxnSpPr>
            <a:cxnSpLocks/>
          </p:cNvCxnSpPr>
          <p:nvPr/>
        </p:nvCxnSpPr>
        <p:spPr>
          <a:xfrm>
            <a:off x="8784877" y="5631587"/>
            <a:ext cx="310657" cy="0"/>
          </a:xfrm>
          <a:prstGeom prst="straightConnector1">
            <a:avLst/>
          </a:prstGeom>
          <a:ln w="285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51D12801-6336-9CE2-1905-FF82AACDFDB1}"/>
              </a:ext>
            </a:extLst>
          </p:cNvPr>
          <p:cNvSpPr txBox="1"/>
          <p:nvPr/>
        </p:nvSpPr>
        <p:spPr>
          <a:xfrm>
            <a:off x="8123990" y="5491311"/>
            <a:ext cx="727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FD4E9EB-18D7-F2FB-EB03-6D07AC96695D}"/>
              </a:ext>
            </a:extLst>
          </p:cNvPr>
          <p:cNvSpPr txBox="1"/>
          <p:nvPr/>
        </p:nvSpPr>
        <p:spPr>
          <a:xfrm>
            <a:off x="8117204" y="5029646"/>
            <a:ext cx="7338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50 </a:t>
            </a:r>
            <a:r>
              <a:rPr lang="en-US" sz="14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CE00977E-B332-283A-D244-0B5D580936B5}"/>
              </a:ext>
            </a:extLst>
          </p:cNvPr>
          <p:cNvSpPr/>
          <p:nvPr/>
        </p:nvSpPr>
        <p:spPr>
          <a:xfrm>
            <a:off x="9359087" y="5277087"/>
            <a:ext cx="1500467" cy="254604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D681F35-6D17-6C90-E34E-C4577E81CCD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55829" y="4855698"/>
            <a:ext cx="1871634" cy="1579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417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1</TotalTime>
  <Words>102</Words>
  <Application>Microsoft Office PowerPoint</Application>
  <PresentationFormat>Widescreen</PresentationFormat>
  <Paragraphs>3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Cincinnat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venson, Camille (stevecv)</dc:creator>
  <cp:lastModifiedBy>Stevenson, Camille (stevecv)</cp:lastModifiedBy>
  <cp:revision>12</cp:revision>
  <cp:lastPrinted>2025-09-10T15:37:51Z</cp:lastPrinted>
  <dcterms:created xsi:type="dcterms:W3CDTF">2025-04-29T15:20:44Z</dcterms:created>
  <dcterms:modified xsi:type="dcterms:W3CDTF">2025-09-11T18:30:52Z</dcterms:modified>
</cp:coreProperties>
</file>